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64" r:id="rId1"/>
  </p:sldMasterIdLst>
  <p:sldIdLst>
    <p:sldId id="256" r:id="rId2"/>
    <p:sldId id="257" r:id="rId3"/>
    <p:sldId id="258" r:id="rId4"/>
    <p:sldId id="259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413423" rtl="0" eaLnBrk="1" latinLnBrk="0" hangingPunct="1">
      <a:defRPr sz="815" kern="1200">
        <a:solidFill>
          <a:schemeClr val="tx1"/>
        </a:solidFill>
        <a:latin typeface="+mn-lt"/>
        <a:ea typeface="+mn-ea"/>
        <a:cs typeface="+mn-cs"/>
      </a:defRPr>
    </a:lvl1pPr>
    <a:lvl2pPr marL="206713" algn="l" defTabSz="413423" rtl="0" eaLnBrk="1" latinLnBrk="0" hangingPunct="1">
      <a:defRPr sz="815" kern="1200">
        <a:solidFill>
          <a:schemeClr val="tx1"/>
        </a:solidFill>
        <a:latin typeface="+mn-lt"/>
        <a:ea typeface="+mn-ea"/>
        <a:cs typeface="+mn-cs"/>
      </a:defRPr>
    </a:lvl2pPr>
    <a:lvl3pPr marL="413423" algn="l" defTabSz="413423" rtl="0" eaLnBrk="1" latinLnBrk="0" hangingPunct="1">
      <a:defRPr sz="815" kern="1200">
        <a:solidFill>
          <a:schemeClr val="tx1"/>
        </a:solidFill>
        <a:latin typeface="+mn-lt"/>
        <a:ea typeface="+mn-ea"/>
        <a:cs typeface="+mn-cs"/>
      </a:defRPr>
    </a:lvl3pPr>
    <a:lvl4pPr marL="620137" algn="l" defTabSz="413423" rtl="0" eaLnBrk="1" latinLnBrk="0" hangingPunct="1">
      <a:defRPr sz="815" kern="1200">
        <a:solidFill>
          <a:schemeClr val="tx1"/>
        </a:solidFill>
        <a:latin typeface="+mn-lt"/>
        <a:ea typeface="+mn-ea"/>
        <a:cs typeface="+mn-cs"/>
      </a:defRPr>
    </a:lvl4pPr>
    <a:lvl5pPr marL="826849" algn="l" defTabSz="413423" rtl="0" eaLnBrk="1" latinLnBrk="0" hangingPunct="1">
      <a:defRPr sz="815" kern="1200">
        <a:solidFill>
          <a:schemeClr val="tx1"/>
        </a:solidFill>
        <a:latin typeface="+mn-lt"/>
        <a:ea typeface="+mn-ea"/>
        <a:cs typeface="+mn-cs"/>
      </a:defRPr>
    </a:lvl5pPr>
    <a:lvl6pPr marL="1033560" algn="l" defTabSz="413423" rtl="0" eaLnBrk="1" latinLnBrk="0" hangingPunct="1">
      <a:defRPr sz="815" kern="1200">
        <a:solidFill>
          <a:schemeClr val="tx1"/>
        </a:solidFill>
        <a:latin typeface="+mn-lt"/>
        <a:ea typeface="+mn-ea"/>
        <a:cs typeface="+mn-cs"/>
      </a:defRPr>
    </a:lvl6pPr>
    <a:lvl7pPr marL="1240272" algn="l" defTabSz="413423" rtl="0" eaLnBrk="1" latinLnBrk="0" hangingPunct="1">
      <a:defRPr sz="815" kern="1200">
        <a:solidFill>
          <a:schemeClr val="tx1"/>
        </a:solidFill>
        <a:latin typeface="+mn-lt"/>
        <a:ea typeface="+mn-ea"/>
        <a:cs typeface="+mn-cs"/>
      </a:defRPr>
    </a:lvl7pPr>
    <a:lvl8pPr marL="1446985" algn="l" defTabSz="413423" rtl="0" eaLnBrk="1" latinLnBrk="0" hangingPunct="1">
      <a:defRPr sz="815" kern="1200">
        <a:solidFill>
          <a:schemeClr val="tx1"/>
        </a:solidFill>
        <a:latin typeface="+mn-lt"/>
        <a:ea typeface="+mn-ea"/>
        <a:cs typeface="+mn-cs"/>
      </a:defRPr>
    </a:lvl8pPr>
    <a:lvl9pPr marL="1653697" algn="l" defTabSz="413423" rtl="0" eaLnBrk="1" latinLnBrk="0" hangingPunct="1">
      <a:defRPr sz="81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6" d="100"/>
          <a:sy n="96" d="100"/>
        </p:scale>
        <p:origin x="124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arghese, Jithu" userId="e10ac4a4-2ec4-4bfd-88a9-ccfe3f6c7358" providerId="ADAL" clId="{3E30B058-AA83-4567-B14F-5219BE585C1B}"/>
    <pc:docChg chg="modSld">
      <pc:chgData name="Varghese, Jithu" userId="e10ac4a4-2ec4-4bfd-88a9-ccfe3f6c7358" providerId="ADAL" clId="{3E30B058-AA83-4567-B14F-5219BE585C1B}" dt="2021-09-07T15:49:50.493" v="1" actId="20577"/>
      <pc:docMkLst>
        <pc:docMk/>
      </pc:docMkLst>
      <pc:sldChg chg="modSp mod">
        <pc:chgData name="Varghese, Jithu" userId="e10ac4a4-2ec4-4bfd-88a9-ccfe3f6c7358" providerId="ADAL" clId="{3E30B058-AA83-4567-B14F-5219BE585C1B}" dt="2021-09-07T15:49:50.493" v="1" actId="20577"/>
        <pc:sldMkLst>
          <pc:docMk/>
          <pc:sldMk cId="2170615322" sldId="260"/>
        </pc:sldMkLst>
        <pc:spChg chg="mod">
          <ac:chgData name="Varghese, Jithu" userId="e10ac4a4-2ec4-4bfd-88a9-ccfe3f6c7358" providerId="ADAL" clId="{3E30B058-AA83-4567-B14F-5219BE585C1B}" dt="2021-09-07T15:49:50.493" v="1" actId="20577"/>
          <ac:spMkLst>
            <pc:docMk/>
            <pc:sldMk cId="2170615322" sldId="260"/>
            <ac:spMk id="2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59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183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788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709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210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77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944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292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818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539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160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2790F-BB82-473E-ABA9-C38C39EF7FD5}" type="datetimeFigureOut">
              <a:rPr lang="en-US" smtClean="0"/>
              <a:t>09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12627-B613-49B5-9FF2-483A35054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687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65" r:id="rId1"/>
    <p:sldLayoutId id="2147483866" r:id="rId2"/>
    <p:sldLayoutId id="2147483867" r:id="rId3"/>
    <p:sldLayoutId id="2147483868" r:id="rId4"/>
    <p:sldLayoutId id="2147483869" r:id="rId5"/>
    <p:sldLayoutId id="2147483870" r:id="rId6"/>
    <p:sldLayoutId id="2147483871" r:id="rId7"/>
    <p:sldLayoutId id="2147483872" r:id="rId8"/>
    <p:sldLayoutId id="2147483873" r:id="rId9"/>
    <p:sldLayoutId id="2147483874" r:id="rId10"/>
    <p:sldLayoutId id="214748387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5" Type="http://schemas.openxmlformats.org/officeDocument/2006/relationships/image" Target="../media/image2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Relationship Id="rId14" Type="http://schemas.openxmlformats.org/officeDocument/2006/relationships/image" Target="../media/image2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f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tiff"/><Relationship Id="rId4" Type="http://schemas.openxmlformats.org/officeDocument/2006/relationships/image" Target="../media/image26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13" Type="http://schemas.openxmlformats.org/officeDocument/2006/relationships/image" Target="../media/image39.jpeg"/><Relationship Id="rId18" Type="http://schemas.openxmlformats.org/officeDocument/2006/relationships/image" Target="../media/image44.tiff"/><Relationship Id="rId3" Type="http://schemas.openxmlformats.org/officeDocument/2006/relationships/image" Target="../media/image29.jpeg"/><Relationship Id="rId21" Type="http://schemas.openxmlformats.org/officeDocument/2006/relationships/image" Target="../media/image47.tiff"/><Relationship Id="rId7" Type="http://schemas.openxmlformats.org/officeDocument/2006/relationships/image" Target="../media/image33.png"/><Relationship Id="rId12" Type="http://schemas.openxmlformats.org/officeDocument/2006/relationships/image" Target="../media/image38.png"/><Relationship Id="rId17" Type="http://schemas.openxmlformats.org/officeDocument/2006/relationships/image" Target="../media/image43.png"/><Relationship Id="rId2" Type="http://schemas.openxmlformats.org/officeDocument/2006/relationships/image" Target="../media/image28.jpeg"/><Relationship Id="rId16" Type="http://schemas.openxmlformats.org/officeDocument/2006/relationships/image" Target="../media/image42.png"/><Relationship Id="rId20" Type="http://schemas.openxmlformats.org/officeDocument/2006/relationships/image" Target="../media/image4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11" Type="http://schemas.openxmlformats.org/officeDocument/2006/relationships/image" Target="../media/image37.png"/><Relationship Id="rId24" Type="http://schemas.openxmlformats.org/officeDocument/2006/relationships/image" Target="../media/image24.jpeg"/><Relationship Id="rId5" Type="http://schemas.openxmlformats.org/officeDocument/2006/relationships/image" Target="../media/image31.jpeg"/><Relationship Id="rId15" Type="http://schemas.openxmlformats.org/officeDocument/2006/relationships/image" Target="../media/image41.png"/><Relationship Id="rId23" Type="http://schemas.openxmlformats.org/officeDocument/2006/relationships/image" Target="../media/image49.tiff"/><Relationship Id="rId10" Type="http://schemas.openxmlformats.org/officeDocument/2006/relationships/image" Target="../media/image36.png"/><Relationship Id="rId19" Type="http://schemas.openxmlformats.org/officeDocument/2006/relationships/image" Target="../media/image45.tiff"/><Relationship Id="rId4" Type="http://schemas.openxmlformats.org/officeDocument/2006/relationships/image" Target="../media/image30.jpeg"/><Relationship Id="rId9" Type="http://schemas.openxmlformats.org/officeDocument/2006/relationships/image" Target="../media/image35.png"/><Relationship Id="rId14" Type="http://schemas.openxmlformats.org/officeDocument/2006/relationships/image" Target="../media/image40.png"/><Relationship Id="rId22" Type="http://schemas.openxmlformats.org/officeDocument/2006/relationships/image" Target="../media/image48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TextBox 62"/>
          <p:cNvSpPr txBox="1"/>
          <p:nvPr/>
        </p:nvSpPr>
        <p:spPr>
          <a:xfrm>
            <a:off x="4948933" y="3083996"/>
            <a:ext cx="19431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ginase1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 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593354" y="306371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72931" y="5470450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48095" y="5492008"/>
            <a:ext cx="17043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3l3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2292649" y="5478039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2597542" y="5478038"/>
            <a:ext cx="16177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l2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7B3345A5-5205-4890-A7E7-074FA1587E86}"/>
              </a:ext>
            </a:extLst>
          </p:cNvPr>
          <p:cNvSpPr txBox="1"/>
          <p:nvPr/>
        </p:nvSpPr>
        <p:spPr>
          <a:xfrm>
            <a:off x="244634" y="237009"/>
            <a:ext cx="643588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Gene expression of inflammatory cytokines and macrophage markers in the 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WAT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fter 12 weeks of CD/HFD feeding</a:t>
            </a:r>
            <a:endParaRPr lang="en-IN" sz="1100" b="1" dirty="0"/>
          </a:p>
        </p:txBody>
      </p:sp>
      <p:sp>
        <p:nvSpPr>
          <p:cNvPr id="2" name="Rectangle 1"/>
          <p:cNvSpPr/>
          <p:nvPr/>
        </p:nvSpPr>
        <p:spPr>
          <a:xfrm>
            <a:off x="172931" y="7967088"/>
            <a:ext cx="6455861" cy="18569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Gene expression of pro-inflammatory cytokines and macrophage markers in the 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WAT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fter 12 weeks of feeding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mRNA levels of TNF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), IL-6 (B), F4/80 (C), </a:t>
            </a:r>
            <a:r>
              <a:rPr lang="en-IN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CP-1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), </a:t>
            </a:r>
            <a:r>
              <a:rPr lang="en-IN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CL5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), </a:t>
            </a:r>
            <a:r>
              <a:rPr lang="en-IN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ginase 1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F), </a:t>
            </a:r>
            <a:r>
              <a:rPr lang="en-IN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i3l3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G) and </a:t>
            </a:r>
            <a:r>
              <a:rPr lang="en-IN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gl2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H) in the </a:t>
            </a:r>
            <a:r>
              <a:rPr lang="en-IN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WAT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WT 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mp1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fed a CD or HFD for 12 weeks.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mRNA levels of </a:t>
            </a:r>
            <a:r>
              <a:rPr lang="en-IN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ginase 1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IN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CP-1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I) in the SVF of WT 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mp1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fed HFD for 24 weeks.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lative expression was calculated by normalising expression of the gene of interest to that of the housekeeping gene, </a:t>
            </a:r>
            <a:r>
              <a:rPr lang="en-IN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prt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Results are shown as mean ± SE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 = 6 in each group.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 were analysed by </a:t>
            </a:r>
            <a:r>
              <a:rPr lang="en-IN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ruskal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–Wallis test, followed by Mann–Whitney U test for pair-wise comparisons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#</a:t>
            </a:r>
            <a:r>
              <a:rPr lang="en-IN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&lt; 0.05 when compared with corresponding genotype in the CD-fed group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453" y="1039104"/>
            <a:ext cx="2012901" cy="199354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656"/>
          <a:stretch/>
        </p:blipFill>
        <p:spPr>
          <a:xfrm>
            <a:off x="2698116" y="1000331"/>
            <a:ext cx="1683138" cy="2071144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115660" y="786092"/>
            <a:ext cx="296905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9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19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47168" y="819834"/>
            <a:ext cx="16754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</a:t>
            </a:r>
            <a:r>
              <a:rPr lang="el-GR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843615" y="761870"/>
            <a:ext cx="1579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6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358069" y="763860"/>
            <a:ext cx="296905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9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19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3354" y="916684"/>
            <a:ext cx="1972786" cy="216158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702" y="3291753"/>
            <a:ext cx="1972786" cy="216158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0571" y="3268952"/>
            <a:ext cx="2005620" cy="2161582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>
            <a:off x="4824821" y="764216"/>
            <a:ext cx="16578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4/80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462920" y="74094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34158" y="3050104"/>
            <a:ext cx="17363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P-1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115660" y="306791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690044" y="3067792"/>
            <a:ext cx="18004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CCL5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445095" y="30418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1306" y="3299518"/>
            <a:ext cx="1928578" cy="2113144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855" y="5729555"/>
            <a:ext cx="1960676" cy="211314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5095" y="5722992"/>
            <a:ext cx="1960676" cy="2113143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746" t="9048" b="64953"/>
          <a:stretch/>
        </p:blipFill>
        <p:spPr>
          <a:xfrm>
            <a:off x="5856164" y="996234"/>
            <a:ext cx="959594" cy="53847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6392" y="5781899"/>
            <a:ext cx="2133492" cy="2253789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4517689" y="5351012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755012" y="5333229"/>
            <a:ext cx="186223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g1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P1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expression in SVF</a:t>
            </a:r>
          </a:p>
          <a:p>
            <a:pPr algn="ctr"/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4 weeks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81817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77693" y="121406"/>
            <a:ext cx="296905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9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19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31095" y="3621366"/>
            <a:ext cx="296905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9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en-US" sz="119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5173" y="3889338"/>
            <a:ext cx="1314450" cy="131565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6768" y="3888450"/>
            <a:ext cx="1314450" cy="130302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3867" y="3904935"/>
            <a:ext cx="1331595" cy="130302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15462" y="3888450"/>
            <a:ext cx="1331595" cy="130302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rot="16200000">
            <a:off x="312147" y="4052411"/>
            <a:ext cx="5565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4/80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818569" y="5284924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11b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83338" y="3708500"/>
            <a:ext cx="11846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-CD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295239" y="3708316"/>
            <a:ext cx="1103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mp1</a:t>
            </a:r>
            <a:r>
              <a:rPr lang="en-IN" sz="11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67350" y="3682272"/>
            <a:ext cx="11846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-HFD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089657" y="3682272"/>
            <a:ext cx="1103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mp1</a:t>
            </a:r>
            <a:r>
              <a:rPr lang="en-IN" sz="11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D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54731" y="5656634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ight Arrow 14"/>
          <p:cNvSpPr/>
          <p:nvPr/>
        </p:nvSpPr>
        <p:spPr>
          <a:xfrm>
            <a:off x="755615" y="5361237"/>
            <a:ext cx="958982" cy="93835"/>
          </a:xfrm>
          <a:prstGeom prst="rightArrow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900271" y="7231503"/>
            <a:ext cx="60785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11c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ight Arrow 16"/>
          <p:cNvSpPr/>
          <p:nvPr/>
        </p:nvSpPr>
        <p:spPr>
          <a:xfrm>
            <a:off x="898591" y="7296169"/>
            <a:ext cx="958982" cy="99091"/>
          </a:xfrm>
          <a:prstGeom prst="rightArrow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6346" y="5886560"/>
            <a:ext cx="1365885" cy="1322007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36993" y="5888711"/>
            <a:ext cx="1371600" cy="130302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74795" y="5888683"/>
            <a:ext cx="1331595" cy="130302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34833" y="5871260"/>
            <a:ext cx="1360170" cy="1303020"/>
          </a:xfrm>
          <a:prstGeom prst="rect">
            <a:avLst/>
          </a:prstGeom>
        </p:spPr>
      </p:pic>
      <p:sp>
        <p:nvSpPr>
          <p:cNvPr id="22" name="Right Arrow 21"/>
          <p:cNvSpPr/>
          <p:nvPr/>
        </p:nvSpPr>
        <p:spPr>
          <a:xfrm rot="16200000">
            <a:off x="394371" y="6734901"/>
            <a:ext cx="620162" cy="97089"/>
          </a:xfrm>
          <a:prstGeom prst="rightArrow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328811" y="5853527"/>
            <a:ext cx="7721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301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79786" y="281379"/>
            <a:ext cx="1258191" cy="116679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163624" y="350328"/>
            <a:ext cx="1141201" cy="1089524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793632" y="352996"/>
            <a:ext cx="1141201" cy="1106088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361785" y="335911"/>
            <a:ext cx="1196161" cy="1137259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12953" y="2113352"/>
            <a:ext cx="1287302" cy="1242396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641052" y="2119947"/>
            <a:ext cx="1263883" cy="1219965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 rot="16200000">
            <a:off x="3293520" y="787929"/>
            <a:ext cx="1011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4/80 - FITC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835082" y="1460677"/>
            <a:ext cx="11961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11b -</a:t>
            </a:r>
            <a:r>
              <a:rPr lang="en-IN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oblue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4845758" y="826400"/>
            <a:ext cx="9348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301 - PE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551206" y="1463763"/>
            <a:ext cx="10374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11c - APC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996578" y="1901753"/>
            <a:ext cx="9220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MO - APC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093494" y="1901753"/>
            <a:ext cx="811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MO - PE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ight Arrow 35"/>
          <p:cNvSpPr/>
          <p:nvPr/>
        </p:nvSpPr>
        <p:spPr>
          <a:xfrm>
            <a:off x="1818052" y="875495"/>
            <a:ext cx="192053" cy="142736"/>
          </a:xfrm>
          <a:prstGeom prst="rightArrow">
            <a:avLst/>
          </a:prstGeom>
          <a:ln w="19050"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203013" y="387812"/>
            <a:ext cx="8531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4/80+CD11b+</a:t>
            </a:r>
            <a:endParaRPr lang="en-US" sz="800" b="1" baseline="300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-25570" y="817878"/>
            <a:ext cx="8739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height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65217" y="1474703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rea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1757432" y="782641"/>
            <a:ext cx="7569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rea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412306" y="1461205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rea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005850" y="5677505"/>
            <a:ext cx="11977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-CD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417750" y="5677321"/>
            <a:ext cx="11157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mp1</a:t>
            </a:r>
            <a:r>
              <a:rPr lang="en-IN" sz="11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789862" y="5657358"/>
            <a:ext cx="11977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-HFD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212168" y="5657358"/>
            <a:ext cx="11157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mp1</a:t>
            </a:r>
            <a:r>
              <a:rPr lang="en-IN" sz="11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D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ight Arrow 45"/>
          <p:cNvSpPr/>
          <p:nvPr/>
        </p:nvSpPr>
        <p:spPr>
          <a:xfrm rot="16200000">
            <a:off x="280347" y="4875520"/>
            <a:ext cx="620162" cy="97089"/>
          </a:xfrm>
          <a:prstGeom prst="rightArrow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78815" y="2621378"/>
            <a:ext cx="9348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301 - PE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794537" y="3349764"/>
            <a:ext cx="10374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11c - APC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2078659" y="2621378"/>
            <a:ext cx="9348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301 - PE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794381" y="3349764"/>
            <a:ext cx="10374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11c - APC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502530" y="412826"/>
            <a:ext cx="718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2-like macrophages</a:t>
            </a:r>
            <a:endParaRPr lang="en-US" sz="7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817419" y="1100879"/>
            <a:ext cx="8069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-like macrophages</a:t>
            </a:r>
            <a:endParaRPr lang="en-US" sz="7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ight Arrow 52"/>
          <p:cNvSpPr/>
          <p:nvPr/>
        </p:nvSpPr>
        <p:spPr>
          <a:xfrm>
            <a:off x="3453202" y="875495"/>
            <a:ext cx="192053" cy="142736"/>
          </a:xfrm>
          <a:prstGeom prst="rightArrow">
            <a:avLst/>
          </a:prstGeom>
          <a:ln w="19050"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975025" y="150345"/>
            <a:ext cx="296905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9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19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591614" y="157013"/>
            <a:ext cx="296905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9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19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071454" y="121406"/>
            <a:ext cx="296905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9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119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08995" y="1783743"/>
            <a:ext cx="296905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9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19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268596" y="1771935"/>
            <a:ext cx="296905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19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US" sz="119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ight Arrow 131">
            <a:extLst>
              <a:ext uri="{FF2B5EF4-FFF2-40B4-BE49-F238E27FC236}">
                <a16:creationId xmlns:a16="http://schemas.microsoft.com/office/drawing/2014/main" xmlns="" id="{2E04F778-915F-4398-B524-2C5477DC63D2}"/>
              </a:ext>
            </a:extLst>
          </p:cNvPr>
          <p:cNvSpPr/>
          <p:nvPr/>
        </p:nvSpPr>
        <p:spPr>
          <a:xfrm>
            <a:off x="4974991" y="828626"/>
            <a:ext cx="192053" cy="142736"/>
          </a:xfrm>
          <a:prstGeom prst="rightArrow">
            <a:avLst/>
          </a:prstGeom>
          <a:ln w="19050"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0" y="7378544"/>
            <a:ext cx="6858000" cy="24801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</a:t>
            </a:r>
            <a:r>
              <a:rPr lang="en-IN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 for determining macrophage content and their phenotypes in the SVF fraction of </a:t>
            </a:r>
            <a:r>
              <a:rPr lang="en-IN" sz="11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WAT</a:t>
            </a:r>
            <a:endParaRPr lang="en-IN" sz="11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IN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in the stromal vascular fraction (SVF)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 labeled with F4/80 (FITC), CD11b (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oblu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CD301 (PE) and CD11c (APC). A and B: The parent population was chosen by excluding cellular debris. These events were then gated for adipose tissue macrophages (ATMs) (C), as those cells co-expressing F4/80 and CD11b. D: Cells expressing surface marker CD 301 were identified as M2-like and cells expressing CD 11c were identified as M1-like macrophages. E and F: Polygon gates were drawn based on fluorescence minus one (FMO) for APC and PE. </a:t>
            </a:r>
            <a:r>
              <a:rPr lang="en-IN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scatter plots for the analysis of macrophages gated as F4/80+ and CD11b+ cells (G) and M1-like and M2-like macrophages (H) in </a:t>
            </a:r>
            <a:r>
              <a:rPr lang="en-IN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WAT</a:t>
            </a:r>
            <a:r>
              <a:rPr lang="en-IN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btained from WT and 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mp1</a:t>
            </a:r>
            <a:r>
              <a:rPr lang="en-US" sz="1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fed a CD or HFD for</a:t>
            </a:r>
            <a:r>
              <a:rPr lang="en-IN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4 weeks</a:t>
            </a: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17052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208239" y="323633"/>
            <a:ext cx="212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89385" y="3944883"/>
            <a:ext cx="13227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 weeks of feeding</a:t>
            </a:r>
            <a:endParaRPr lang="en-US" sz="11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706937" y="3838640"/>
            <a:ext cx="13227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 weeks of feeding</a:t>
            </a:r>
            <a:endParaRPr lang="en-US" sz="11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799627" y="315937"/>
            <a:ext cx="13227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 weeks of feeding</a:t>
            </a:r>
            <a:endParaRPr lang="en-US" sz="11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780" t="3811" r="2097" b="80542"/>
          <a:stretch/>
        </p:blipFill>
        <p:spPr>
          <a:xfrm>
            <a:off x="3154087" y="4206494"/>
            <a:ext cx="840044" cy="438619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642501" y="3960273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243337" y="389299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94906" y="6716213"/>
            <a:ext cx="6152721" cy="2410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: </a:t>
            </a:r>
            <a:r>
              <a:rPr lang="en-IN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equency distribution of adipocytes of different sizes in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WAT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triglyceride content in liver and skeletal muscles of wild-type and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mp1</a:t>
            </a:r>
            <a:r>
              <a:rPr lang="en-US" sz="1200" b="1" i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equency distribution of adipocytes based on  diameter (A) in WT 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mp1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fed CD for 24 weeks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 = 3 in each group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riglyceride content in the liver (B) and quadriceps muscle (C) of WT 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mp1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fed a CD or HFD for 12 weeks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 = 4 in each group.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 are shown as the mean ± S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 were analysed by </a:t>
            </a:r>
            <a:r>
              <a:rPr lang="en-IN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ruskal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–Wallis test, followed by Mann–Whitney U test for pair-wise comparisons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IN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&lt; 0.05 when compared with corresponding WT group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3242" y="716145"/>
            <a:ext cx="3113532" cy="2939796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530" y="4206493"/>
            <a:ext cx="2354580" cy="240792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4119" y="4202050"/>
            <a:ext cx="2252472" cy="240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03401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4252" y="233331"/>
            <a:ext cx="290464" cy="2680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4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14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323884" y="233332"/>
            <a:ext cx="282450" cy="2680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4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14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373523" y="2692328"/>
            <a:ext cx="290464" cy="2680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4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14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40546" y="5085081"/>
            <a:ext cx="290464" cy="2680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4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sz="114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87635" y="3347658"/>
            <a:ext cx="548548" cy="2173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IN" sz="81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81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92914" y="3628772"/>
            <a:ext cx="497252" cy="2173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en-IN" sz="81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81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499825" y="4161366"/>
            <a:ext cx="548548" cy="2173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IN" sz="81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81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513679" y="4425867"/>
            <a:ext cx="497252" cy="2173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en-IN" sz="81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81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85959" y="3650354"/>
            <a:ext cx="570387" cy="2173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IN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US" sz="81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63007" y="3369439"/>
            <a:ext cx="518058" cy="2173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R1</a:t>
            </a:r>
            <a:endParaRPr lang="en-US" sz="81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85959" y="4430727"/>
            <a:ext cx="570387" cy="2173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IN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US" sz="81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74334" y="4207715"/>
            <a:ext cx="518058" cy="2173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R1</a:t>
            </a:r>
            <a:endParaRPr lang="en-US" sz="81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89062" y="3945693"/>
            <a:ext cx="593432" cy="2173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81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D,WT</a:t>
            </a:r>
            <a:endParaRPr lang="en-US" sz="812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317703" y="3934167"/>
            <a:ext cx="817853" cy="21730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1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D,Hamp1</a:t>
            </a:r>
            <a:r>
              <a:rPr lang="en-US" sz="812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lang="en-US" sz="812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31641" y="3053615"/>
            <a:ext cx="511679" cy="2173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81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,WT</a:t>
            </a:r>
            <a:endParaRPr lang="en-US" sz="812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1356104" y="3060814"/>
            <a:ext cx="742541" cy="2173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1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,Hamp1</a:t>
            </a:r>
            <a:r>
              <a:rPr lang="en-US" sz="812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lang="en-US" sz="812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 flipV="1">
            <a:off x="728804" y="3258272"/>
            <a:ext cx="462893" cy="45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677455" y="4724599"/>
            <a:ext cx="1320492" cy="213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977601" y="4761094"/>
            <a:ext cx="680194" cy="2173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 weeks</a:t>
            </a:r>
            <a:endParaRPr lang="en-US" sz="81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05" t="50000" r="1" b="14532"/>
          <a:stretch/>
        </p:blipFill>
        <p:spPr>
          <a:xfrm>
            <a:off x="274347" y="750161"/>
            <a:ext cx="926397" cy="7194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60" t="44663" r="3691" b="18723"/>
          <a:stretch/>
        </p:blipFill>
        <p:spPr>
          <a:xfrm>
            <a:off x="1264420" y="753656"/>
            <a:ext cx="947095" cy="7124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11" t="44569" r="19442" b="28454"/>
          <a:stretch/>
        </p:blipFill>
        <p:spPr>
          <a:xfrm>
            <a:off x="1277587" y="1550884"/>
            <a:ext cx="947096" cy="729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9" t="54913" r="59719" b="22494"/>
          <a:stretch/>
        </p:blipFill>
        <p:spPr>
          <a:xfrm>
            <a:off x="276566" y="1568043"/>
            <a:ext cx="926398" cy="7097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Box 24"/>
          <p:cNvSpPr txBox="1"/>
          <p:nvPr/>
        </p:nvSpPr>
        <p:spPr>
          <a:xfrm>
            <a:off x="548786" y="533010"/>
            <a:ext cx="1594476" cy="233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1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                         HFD</a:t>
            </a:r>
            <a:endParaRPr lang="en-US" sz="91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-265608" y="958091"/>
            <a:ext cx="774546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1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</a:t>
            </a:r>
            <a:endParaRPr lang="en-US" sz="101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-377378" y="1798664"/>
            <a:ext cx="981226" cy="24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5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mp1</a:t>
            </a:r>
            <a:r>
              <a:rPr lang="en-US" sz="1015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sz="1015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endParaRPr lang="en-US" sz="101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Picture 2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328018" y="755664"/>
            <a:ext cx="982564" cy="71248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29" name="Picture 3"/>
          <p:cNvPicPr>
            <a:picLocks noChangeAspect="1" noChangeArrowheads="1"/>
          </p:cNvPicPr>
          <p:nvPr/>
        </p:nvPicPr>
        <p:blipFill rotWithShape="1">
          <a:blip r:embed="rId7"/>
          <a:srcRect b="14159"/>
          <a:stretch/>
        </p:blipFill>
        <p:spPr bwMode="auto">
          <a:xfrm>
            <a:off x="2351206" y="755199"/>
            <a:ext cx="938518" cy="71357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30" name="Picture 4"/>
          <p:cNvPicPr>
            <a:picLocks noChangeAspect="1" noChangeArrowheads="1"/>
          </p:cNvPicPr>
          <p:nvPr/>
        </p:nvPicPr>
        <p:blipFill rotWithShape="1">
          <a:blip r:embed="rId8"/>
          <a:srcRect l="8535"/>
          <a:stretch/>
        </p:blipFill>
        <p:spPr bwMode="auto">
          <a:xfrm>
            <a:off x="2342045" y="1548114"/>
            <a:ext cx="931734" cy="7224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31" name="Picture 5"/>
          <p:cNvPicPr>
            <a:picLocks noChangeAspect="1" noChangeArrowheads="1"/>
          </p:cNvPicPr>
          <p:nvPr/>
        </p:nvPicPr>
        <p:blipFill rotWithShape="1">
          <a:blip r:embed="rId9"/>
          <a:srcRect r="2823"/>
          <a:stretch/>
        </p:blipFill>
        <p:spPr bwMode="auto">
          <a:xfrm>
            <a:off x="3315001" y="1541125"/>
            <a:ext cx="995576" cy="72243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32" name="TextBox 31"/>
          <p:cNvSpPr txBox="1"/>
          <p:nvPr/>
        </p:nvSpPr>
        <p:spPr>
          <a:xfrm>
            <a:off x="2651048" y="522844"/>
            <a:ext cx="1594476" cy="233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1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                         HFD</a:t>
            </a:r>
            <a:endParaRPr lang="en-US" sz="91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Straight Connector 32"/>
          <p:cNvCxnSpPr/>
          <p:nvPr/>
        </p:nvCxnSpPr>
        <p:spPr>
          <a:xfrm>
            <a:off x="246673" y="2355595"/>
            <a:ext cx="1978013" cy="45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913006" y="2399085"/>
            <a:ext cx="738163" cy="233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1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 weeks</a:t>
            </a:r>
            <a:endParaRPr lang="en-US" sz="91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 flipV="1">
            <a:off x="2351206" y="2355596"/>
            <a:ext cx="1959371" cy="62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945923" y="2399085"/>
            <a:ext cx="738163" cy="233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1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 weeks</a:t>
            </a:r>
            <a:endParaRPr lang="en-US" sz="914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Picture 2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88" t="57618" r="19020" b="11906"/>
          <a:stretch/>
        </p:blipFill>
        <p:spPr bwMode="auto">
          <a:xfrm>
            <a:off x="652086" y="3342854"/>
            <a:ext cx="1402373" cy="2208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" name="Picture 7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38" t="14444" r="20469" b="-3332"/>
          <a:stretch/>
        </p:blipFill>
        <p:spPr bwMode="auto">
          <a:xfrm>
            <a:off x="652308" y="3642968"/>
            <a:ext cx="1402373" cy="22847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9" name="Picture 7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90" r="20737"/>
          <a:stretch/>
        </p:blipFill>
        <p:spPr bwMode="auto">
          <a:xfrm>
            <a:off x="649289" y="4445896"/>
            <a:ext cx="1407966" cy="21049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881" y="4197600"/>
            <a:ext cx="1402373" cy="2008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2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10" t="29858" r="14080" b="15929"/>
          <a:stretch/>
        </p:blipFill>
        <p:spPr bwMode="auto">
          <a:xfrm>
            <a:off x="2139577" y="3636560"/>
            <a:ext cx="1390161" cy="2328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2" name="Picture 3"/>
          <p:cNvPicPr>
            <a:picLocks noChangeAspect="1" noChangeArrowheads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72" t="37500" r="19778"/>
          <a:stretch/>
        </p:blipFill>
        <p:spPr bwMode="auto">
          <a:xfrm>
            <a:off x="2143199" y="3345077"/>
            <a:ext cx="1402373" cy="2336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3" name="Picture 42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70" t="35626" r="12427" b="6249"/>
          <a:stretch/>
        </p:blipFill>
        <p:spPr bwMode="auto">
          <a:xfrm>
            <a:off x="2124055" y="4210614"/>
            <a:ext cx="1392820" cy="2087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4" name="Picture 5"/>
          <p:cNvPicPr>
            <a:picLocks noChangeAspect="1" noChangeArrowheads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88" t="12437" r="11079" b="-8878"/>
          <a:stretch/>
        </p:blipFill>
        <p:spPr bwMode="auto">
          <a:xfrm>
            <a:off x="2143360" y="4462911"/>
            <a:ext cx="1402212" cy="22103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5" name="Straight Connector 44"/>
          <p:cNvCxnSpPr/>
          <p:nvPr/>
        </p:nvCxnSpPr>
        <p:spPr>
          <a:xfrm flipV="1">
            <a:off x="1463459" y="3265959"/>
            <a:ext cx="462893" cy="45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V="1">
            <a:off x="733325" y="4141185"/>
            <a:ext cx="462893" cy="45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V="1">
            <a:off x="1439252" y="4138891"/>
            <a:ext cx="462893" cy="45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2173021" y="3925080"/>
            <a:ext cx="593432" cy="2173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81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D,WT</a:t>
            </a:r>
            <a:endParaRPr lang="en-US" sz="812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226548" y="3059660"/>
            <a:ext cx="511679" cy="2173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81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,WT</a:t>
            </a:r>
            <a:endParaRPr lang="en-US" sz="812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2851223" y="3048198"/>
            <a:ext cx="742541" cy="2173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1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,Hamp1</a:t>
            </a:r>
            <a:r>
              <a:rPr lang="en-US" sz="812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lang="en-US" sz="812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Straight Connector 52"/>
          <p:cNvCxnSpPr/>
          <p:nvPr/>
        </p:nvCxnSpPr>
        <p:spPr>
          <a:xfrm flipV="1">
            <a:off x="2208790" y="4138891"/>
            <a:ext cx="462893" cy="45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V="1">
            <a:off x="2965380" y="4138416"/>
            <a:ext cx="462893" cy="45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2847122" y="3911813"/>
            <a:ext cx="817853" cy="21730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1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FD,Hamp1</a:t>
            </a:r>
            <a:r>
              <a:rPr lang="en-US" sz="812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lang="en-US" sz="812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6" name="Straight Connector 55"/>
          <p:cNvCxnSpPr/>
          <p:nvPr/>
        </p:nvCxnSpPr>
        <p:spPr>
          <a:xfrm>
            <a:off x="2117320" y="4723982"/>
            <a:ext cx="1320492" cy="213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2417466" y="4760478"/>
            <a:ext cx="680194" cy="2173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81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 weeks</a:t>
            </a:r>
            <a:endParaRPr lang="en-US" sz="81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836837" y="5143435"/>
            <a:ext cx="282450" cy="2680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4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sz="114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848561" y="7619365"/>
            <a:ext cx="274434" cy="2680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4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US" sz="114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947044" y="7694531"/>
            <a:ext cx="298480" cy="2680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14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en-US" sz="114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606737" y="237313"/>
            <a:ext cx="2238113" cy="2642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1117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R1 </a:t>
            </a:r>
            <a:r>
              <a:rPr lang="en-US" sz="111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 in </a:t>
            </a:r>
            <a:r>
              <a:rPr lang="en-US" sz="1117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WAT</a:t>
            </a:r>
            <a:endParaRPr lang="en-US" sz="1117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448731" y="2677183"/>
            <a:ext cx="22124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R1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expression in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WAT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5" r="11306" b="3529"/>
          <a:stretch/>
        </p:blipFill>
        <p:spPr>
          <a:xfrm>
            <a:off x="4425992" y="513461"/>
            <a:ext cx="2416540" cy="2114888"/>
          </a:xfrm>
          <a:prstGeom prst="rect">
            <a:avLst/>
          </a:prstGeom>
        </p:spPr>
      </p:pic>
      <p:sp>
        <p:nvSpPr>
          <p:cNvPr id="64" name="TextBox 63"/>
          <p:cNvSpPr txBox="1"/>
          <p:nvPr/>
        </p:nvSpPr>
        <p:spPr>
          <a:xfrm>
            <a:off x="362508" y="237313"/>
            <a:ext cx="3890354" cy="264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17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ls</a:t>
            </a:r>
            <a:r>
              <a:rPr lang="en-US" sz="111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staining by in-situ perfusion in </a:t>
            </a:r>
            <a:r>
              <a:rPr lang="en-US" sz="1117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WAT</a:t>
            </a:r>
            <a:endParaRPr lang="en-US" sz="1117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5" name="Picture 64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54" r="10195" b="1"/>
          <a:stretch/>
        </p:blipFill>
        <p:spPr>
          <a:xfrm>
            <a:off x="4190390" y="3045248"/>
            <a:ext cx="2486054" cy="2032016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1" t="4088" r="8988"/>
          <a:stretch/>
        </p:blipFill>
        <p:spPr>
          <a:xfrm>
            <a:off x="373557" y="5470796"/>
            <a:ext cx="2895919" cy="2122443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74" r="8985" b="4035"/>
          <a:stretch/>
        </p:blipFill>
        <p:spPr>
          <a:xfrm>
            <a:off x="3684086" y="5451151"/>
            <a:ext cx="2932594" cy="2082046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2" t="6369" r="10352" b="3436"/>
          <a:stretch/>
        </p:blipFill>
        <p:spPr>
          <a:xfrm>
            <a:off x="533363" y="7955803"/>
            <a:ext cx="2650670" cy="1985815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1" t="4406" r="8391" b="4325"/>
          <a:stretch/>
        </p:blipFill>
        <p:spPr>
          <a:xfrm>
            <a:off x="3836837" y="7960987"/>
            <a:ext cx="2904365" cy="2012061"/>
          </a:xfrm>
          <a:prstGeom prst="rect">
            <a:avLst/>
          </a:prstGeom>
        </p:spPr>
      </p:pic>
      <p:sp>
        <p:nvSpPr>
          <p:cNvPr id="70" name="TextBox 69"/>
          <p:cNvSpPr txBox="1"/>
          <p:nvPr/>
        </p:nvSpPr>
        <p:spPr>
          <a:xfrm>
            <a:off x="1279415" y="5099873"/>
            <a:ext cx="1648208" cy="2642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111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on content in the liver</a:t>
            </a:r>
            <a:endParaRPr lang="en-US" sz="1117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190390" y="5147282"/>
            <a:ext cx="2291013" cy="2642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111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on content in the skeletal muscle</a:t>
            </a:r>
            <a:endParaRPr lang="en-US" sz="1117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684446" y="7665437"/>
            <a:ext cx="883575" cy="2642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111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um iron</a:t>
            </a:r>
            <a:endParaRPr lang="en-US" sz="1117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4648041" y="7665406"/>
            <a:ext cx="1752404" cy="2642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IN" sz="111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on content in the spleen</a:t>
            </a:r>
            <a:endParaRPr lang="en-US" sz="1117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4" name="Picture 73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780" t="3811" r="2097" b="80542"/>
          <a:stretch/>
        </p:blipFill>
        <p:spPr>
          <a:xfrm>
            <a:off x="5884830" y="615759"/>
            <a:ext cx="840044" cy="438619"/>
          </a:xfrm>
          <a:prstGeom prst="rect">
            <a:avLst/>
          </a:prstGeom>
        </p:spPr>
      </p:pic>
      <p:sp>
        <p:nvSpPr>
          <p:cNvPr id="75" name="Rectangle 74"/>
          <p:cNvSpPr/>
          <p:nvPr/>
        </p:nvSpPr>
        <p:spPr>
          <a:xfrm>
            <a:off x="2680858" y="3964407"/>
            <a:ext cx="296876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Straight Connector 78"/>
          <p:cNvCxnSpPr/>
          <p:nvPr/>
        </p:nvCxnSpPr>
        <p:spPr>
          <a:xfrm flipV="1">
            <a:off x="2208790" y="3235878"/>
            <a:ext cx="583077" cy="22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 flipV="1">
            <a:off x="2857120" y="3242238"/>
            <a:ext cx="583077" cy="22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645377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90393" y="694396"/>
            <a:ext cx="6092019" cy="27802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: </a:t>
            </a:r>
            <a:r>
              <a:rPr lang="en-IN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rkers of iron status in the </a:t>
            </a:r>
            <a:r>
              <a:rPr lang="en-IN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WAT</a:t>
            </a:r>
            <a:r>
              <a:rPr lang="en-IN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iver, skeletal muscle, serum and spleen of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ld-type and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mp1</a:t>
            </a:r>
            <a:r>
              <a:rPr lang="en-US" sz="1200" b="1" i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ages 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on staining of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WA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, afte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tu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fusion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perfusion fluid,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mp1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fed CD or HFD for 12 and 24 weeks. The mRNA levels of TfR1 (B), representative images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uantification of western blots for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R1 (C) in the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WAT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mp1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fed CD or HFD for 12 weeks or 24 weeks 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C= normalising control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 to normalize between blots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levels of TfR1 were normalised to that of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, which was used as the loading contro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ron content in the liver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eletal muscle (E), serum (F) and spleen (G)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T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mp1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, fed CD or HFD for 12 and 24 weeks.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are shown as the mean ± SE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3 to 5 in each group.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were analysed by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Wallis test, followed by Mann–Whitney U test for pair-wise comparisons. *</a:t>
            </a:r>
            <a:r>
              <a:rPr lang="en-I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 0.05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I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 0.01 when compared with corresponding WT group; #</a:t>
            </a:r>
            <a:r>
              <a:rPr lang="en-I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 0.05 when compared with corresponding genotype in the CD-fed group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0615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52</TotalTime>
  <Words>824</Words>
  <Application>Microsoft Office PowerPoint</Application>
  <PresentationFormat>A4 Paper (210x297 mm)</PresentationFormat>
  <Paragraphs>11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jithu</cp:lastModifiedBy>
  <cp:revision>66</cp:revision>
  <dcterms:created xsi:type="dcterms:W3CDTF">2017-09-23T04:58:39Z</dcterms:created>
  <dcterms:modified xsi:type="dcterms:W3CDTF">2021-09-09T08:29:00Z</dcterms:modified>
</cp:coreProperties>
</file>